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58" r:id="rId2"/>
    <p:sldId id="259" r:id="rId3"/>
    <p:sldId id="260" r:id="rId4"/>
    <p:sldId id="262" r:id="rId5"/>
    <p:sldId id="263" r:id="rId6"/>
    <p:sldId id="266" r:id="rId7"/>
    <p:sldId id="26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979"/>
    <p:restoredTop sz="94694"/>
  </p:normalViewPr>
  <p:slideViewPr>
    <p:cSldViewPr snapToGrid="0">
      <p:cViewPr varScale="1">
        <p:scale>
          <a:sx n="121" d="100"/>
          <a:sy n="121" d="100"/>
        </p:scale>
        <p:origin x="104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91EE1C-498C-8D40-B58E-FCCD88B50C97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9CF812-C565-B349-9AB6-516592DFC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6563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9CF812-C565-B349-9AB6-516592DFCBEE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3486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1434B9-560F-B259-AD59-65FEDA05C9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761BE7-4996-538B-DD76-3DA6A5D39D5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AE9A1B-2E29-00F1-0FA5-BAF4D9DC8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AD8F59-C3D9-C6F2-AF39-54D9FE3DF3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06D2B1-97BC-57EE-A45C-D9918E4D3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8836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91C97E-CF15-621E-C194-81077257C7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62AA1DD-3AFF-7CB9-9EE4-00053E1E59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486BC-6606-E347-F365-62F352970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7AB1DCA-2568-5C30-71AF-501B6A636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DF10BC-F01F-5006-5125-2855197C46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CC3E13-C4EB-7558-9203-02C8ED275B3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65F20E-41EB-8C3A-8E8D-CC996D2D372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8B5EF-2FE6-6402-FAF1-51A7B7E706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6A2E86-9276-6488-6983-EE431EC16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A96459-38F4-2EE4-034F-5AB7A21FB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18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E67605-2721-5939-EAF5-C6B78DC033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572CE1B-253B-61F7-2D37-DA4A4E4EFD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143EB1-6B1D-9FD1-BECB-7BF44E6BD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B9634E-966D-B2C9-E3D9-7F7974285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AB4538-7F03-0CBA-4530-6EAD50A3CC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3176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8631A-E1FC-9F2A-E1B5-E38D0EE0F4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260F01-D268-D62B-2FA4-307BC4A287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CAE23E-C0E2-4CDC-91DD-1F285C32C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54972E-7F78-FC98-62B4-DEE3591CC5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4690AC-46C1-E197-DCDC-FEC821C73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32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8D29AA-D5DE-1ED4-77D4-AF40E27B28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7EA0EF-5788-07C0-C50B-EC7B0F3294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368519-113D-8FDA-B420-575150E933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9862A7-5E61-02B2-057B-67825FC49E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9EA9D-AB85-D0D2-CA78-8D94CE86E5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562DF6-0BE1-5245-D2BA-74263956AF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366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FA9873-0DAA-8DB8-15E0-0E287FF389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B220AD-3AD0-E4FB-6DAE-487E9BDA53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404432-14C9-1DB6-DAC0-B8D4846173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46AA2AC-39E9-E595-0C0D-FA1F9DCD6F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1295D1A-B453-8DFE-F25D-40D32AEAD6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CE2C2ED-8273-CD24-383C-0934B99A9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C8A6572-07A4-4A9D-4117-18CFE63D3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ED2C9BD-E967-51F1-822F-6A72D65382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374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03FF76-F8B4-B4FC-32A8-64F80430AF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09831A-65DA-A2DD-7921-99449A3B6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CDDD8C-7613-C3C6-5128-A9DAE6BA8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5B2647B-1BE8-979B-9C05-40F95E1C7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212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52762E2-50A2-E6DD-03A3-802EEC8442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401B954-2ACA-DF2B-39FE-A230C2E046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ABC41A-EBE7-CCE3-2D75-E0BDDE2D3E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4470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6F8F8-9807-A0C5-DB8F-EA8527DE0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386FAB-30DF-5A09-1E57-D4DEBB9E13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B30A08-9406-916C-D294-46D9958EDF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EBCC18D-780A-0528-216F-BDB2F3434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35A9D8-7865-0DAE-AF6F-343A2513EC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307194-3BB2-34C4-28AC-B45595BCE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89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67C8F-DF87-E9C1-26E5-273F36EF86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E51E84E-CEAD-06F5-2A69-CC246E2159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33AC2C-2849-139A-26EE-D1DD76D27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61194B-6B77-EE37-CE3C-6598B84E3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CD4065-18A7-C5A0-500C-3F5331A50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9601D3-384D-A54C-FFB9-0054B783E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726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1C1FAA-0D31-B2E2-684A-39FC464DDF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F5DB3A-8DAC-B51F-7A58-4BE1BCDE59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99FEC3-3F33-0340-5624-E9236C728A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14B4312-B33A-4649-B704-8816CC189FA3}" type="datetimeFigureOut">
              <a:rPr lang="en-US" smtClean="0"/>
              <a:t>12/1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C6A716-4659-6D50-C371-3AA15EB291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6E2B72-5259-13B6-ACFD-F8598C4C40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888C77F-E4AE-EC48-A8BD-F9ACC13C6D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880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746B98-8CC3-2530-731E-B4E71E7FC60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4F5E0E5-A494-DED3-D85B-B72C72296102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238258-EBA2-3040-4BBE-649B5A4BB819}"/>
              </a:ext>
            </a:extLst>
          </p:cNvPr>
          <p:cNvSpPr txBox="1"/>
          <p:nvPr/>
        </p:nvSpPr>
        <p:spPr>
          <a:xfrm>
            <a:off x="0" y="0"/>
            <a:ext cx="2583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7B9C6C9-1F93-8F3F-2B98-9FF1112452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3771" y="369332"/>
            <a:ext cx="9155089" cy="64886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4569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6C060C5-FDFC-A90A-9629-6A3F717DAC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9F818F5-8324-67E4-A57E-9E2E83C7CCF7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3472F95-7FD8-7BD7-5635-7E8CD4544FB0}"/>
              </a:ext>
            </a:extLst>
          </p:cNvPr>
          <p:cNvSpPr txBox="1"/>
          <p:nvPr/>
        </p:nvSpPr>
        <p:spPr>
          <a:xfrm>
            <a:off x="0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4B1F691-F9D7-A842-D95C-E04C39EACC3D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33185"/>
          <a:stretch>
            <a:fillRect/>
          </a:stretch>
        </p:blipFill>
        <p:spPr>
          <a:xfrm>
            <a:off x="2157249" y="444500"/>
            <a:ext cx="7696200" cy="428515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C49DABF-8FAF-EEB3-94F6-396FC0276F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95095" y="4704859"/>
            <a:ext cx="9949407" cy="21531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67765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8AD648-27CF-EAAF-B86C-88252EDB33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9DB8F1F-A69C-D123-3D5F-4AB769B5DE60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ED6B4B-C2C7-9EEE-9185-44181DA1D5F0}"/>
              </a:ext>
            </a:extLst>
          </p:cNvPr>
          <p:cNvSpPr txBox="1"/>
          <p:nvPr/>
        </p:nvSpPr>
        <p:spPr>
          <a:xfrm>
            <a:off x="-224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6F81D6C-2114-5800-9FCD-13A4FFEE0250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3955" t="71086"/>
          <a:stretch>
            <a:fillRect/>
          </a:stretch>
        </p:blipFill>
        <p:spPr>
          <a:xfrm>
            <a:off x="822640" y="1706772"/>
            <a:ext cx="10546719" cy="29534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6971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15F9FA-E07F-D873-7042-753A7BABC0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74574D8-9E97-B0DC-ADA5-824B4DFC8B9E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90016FC-2E90-1E4C-8268-F02764FA80BF}"/>
              </a:ext>
            </a:extLst>
          </p:cNvPr>
          <p:cNvSpPr txBox="1"/>
          <p:nvPr/>
        </p:nvSpPr>
        <p:spPr>
          <a:xfrm>
            <a:off x="-224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E2ED30FF-7C64-F79D-B3DC-D45CCB17C3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2100" y="881117"/>
            <a:ext cx="8196728" cy="28185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55118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846ECA-0A73-5845-F66D-19AD9BC770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68B58806-3D6D-755D-925C-D72B6EDB87AB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4469F53-657E-D7ED-82FF-AEC6678CC71F}"/>
              </a:ext>
            </a:extLst>
          </p:cNvPr>
          <p:cNvSpPr txBox="1"/>
          <p:nvPr/>
        </p:nvSpPr>
        <p:spPr>
          <a:xfrm>
            <a:off x="-224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5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8B8DD581-0E29-2427-4BB9-AB784141A7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" y="570721"/>
            <a:ext cx="12192000" cy="6197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72088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1B4D36F-35F4-6343-ADF0-40169F6329B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3BD08AF8-D859-F491-27A4-6890D79F875F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3B2574-2AED-C134-B4E2-885C80198AA5}"/>
              </a:ext>
            </a:extLst>
          </p:cNvPr>
          <p:cNvSpPr txBox="1"/>
          <p:nvPr/>
        </p:nvSpPr>
        <p:spPr>
          <a:xfrm>
            <a:off x="-224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6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D6684C7-552B-6A86-A775-926B533304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1025403"/>
            <a:ext cx="11924954" cy="54384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24217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067D606-AD01-DAB5-2927-49C1196B9F6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266EEA0C-9C1A-EC83-31AA-1B867B7410E1}"/>
              </a:ext>
            </a:extLst>
          </p:cNvPr>
          <p:cNvSpPr txBox="1"/>
          <p:nvPr/>
        </p:nvSpPr>
        <p:spPr>
          <a:xfrm>
            <a:off x="10593164" y="0"/>
            <a:ext cx="1598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earson et al.,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5FF8EA-6CBD-0551-51BC-E405F7D69021}"/>
              </a:ext>
            </a:extLst>
          </p:cNvPr>
          <p:cNvSpPr txBox="1"/>
          <p:nvPr/>
        </p:nvSpPr>
        <p:spPr>
          <a:xfrm>
            <a:off x="-22441" y="0"/>
            <a:ext cx="24557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1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E15735B-147D-5AEC-C3C0-3F2B05546F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5065348"/>
              </p:ext>
            </p:extLst>
          </p:nvPr>
        </p:nvGraphicFramePr>
        <p:xfrm>
          <a:off x="2939174" y="105522"/>
          <a:ext cx="5963088" cy="664695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30722">
                  <a:extLst>
                    <a:ext uri="{9D8B030D-6E8A-4147-A177-3AD203B41FA5}">
                      <a16:colId xmlns:a16="http://schemas.microsoft.com/office/drawing/2014/main" val="909662535"/>
                    </a:ext>
                  </a:extLst>
                </a:gridCol>
                <a:gridCol w="4332366">
                  <a:extLst>
                    <a:ext uri="{9D8B030D-6E8A-4147-A177-3AD203B41FA5}">
                      <a16:colId xmlns:a16="http://schemas.microsoft.com/office/drawing/2014/main" val="839823523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237081527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7a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CCTCAAAGCTCAGCGTG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572922918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TCTTCATTGCGGTGGAGA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252935956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18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CAAGCAAGAAAGTGTCC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298508751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TGAACCCCAGACCAGA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26698078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22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ATCTTTAGCACTGACTCCTC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706885424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CTGCCCGTCAACACCCG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564619591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23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TGTTGTCCTTGAGTC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306844164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GTGCCTAGGAGTAGCA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660113607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amp</a:t>
                      </a:r>
                      <a:endParaRPr lang="en-GB" sz="1200" b="1" i="1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CCCCATACACTGCTTCAC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469678594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GAGCTGTGGATGACTTC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966705811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p-ductin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ACCGTGTGACAGTGGTCTTC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682074608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CCTTGTCACACTGCCATCTG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221575727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fcr10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ATCCAGGTGATTCCCAGCCA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532486026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GGGTCTCCAAAGGAAACAG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197658414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mb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CTCTCAGTCGTCAAGAGCCTAA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008928348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AAGCACATCCAGTGACAACC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408517079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3beta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CCTTAGACCGTGCTT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527848149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TTGTCCATGATGCTCT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072353245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g3gamma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TGTCCTCCATGATCAAA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159799771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TCCACCTCTGTTGGGTTCA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402562088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laudin2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TGCCCACCACAGAGATA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774747930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TGTTGGTGCCAGCATTGT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531663263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onulin1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CGGAGTGATGGTTTTCT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08412174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TCTGTCCAGCTCT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048325058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fb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GAGGAGTCTGCGGCACATTAG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158511778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CCCACTGCTGCCTCCCGTA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966026654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-2</a:t>
                      </a:r>
                      <a:r>
                        <a:rPr lang="en-GB" sz="1200" b="1" i="1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</a:t>
                      </a:r>
                      <a:r>
                        <a:rPr lang="en-GB" sz="12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CACTGTCTCCAACATGGC</a:t>
                      </a: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816874641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pPr algn="ctr" fontAlgn="b"/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CCCCTCCTTTTCCACCTGT</a:t>
                      </a: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291141377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-2d</a:t>
                      </a:r>
                      <a:r>
                        <a:rPr lang="en-GB" sz="12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TGGTGCTGCAGAGCATTACAA 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041848166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pPr algn="ctr" fontAlgn="b"/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GACTTCACCTTTAGATCTGG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580153506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-a</a:t>
                      </a:r>
                      <a:r>
                        <a:rPr lang="en-GB" sz="12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7</a:t>
                      </a: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TGGTGCTGATGGTGCTG</a:t>
                      </a: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82551248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pPr algn="ctr" fontAlgn="b"/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b="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ATGAACTGGTACACGAAATG</a:t>
                      </a: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212973992"/>
                  </a:ext>
                </a:extLst>
              </a:tr>
              <a:tr h="150046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GB" sz="1200" b="1" i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en-GB" sz="1200" b="1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CATCAAGAAGGTGGTGAAG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734001816"/>
                  </a:ext>
                </a:extLst>
              </a:tr>
              <a:tr h="15004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TGTAGCCGTATTCATTGTC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0142504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46349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31</TotalTime>
  <Words>104</Words>
  <Application>Microsoft Macintosh PowerPoint</Application>
  <PresentationFormat>Widescreen</PresentationFormat>
  <Paragraphs>68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mes Pearson</dc:creator>
  <cp:lastModifiedBy>James Pearson</cp:lastModifiedBy>
  <cp:revision>21</cp:revision>
  <dcterms:created xsi:type="dcterms:W3CDTF">2025-04-23T12:50:43Z</dcterms:created>
  <dcterms:modified xsi:type="dcterms:W3CDTF">2025-12-12T20:46:46Z</dcterms:modified>
</cp:coreProperties>
</file>